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8" d="100"/>
          <a:sy n="68" d="100"/>
        </p:scale>
        <p:origin x="84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53F89DF-3C79-44C1-AF34-4D0D45C43A9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D3A40339-B38E-4259-9DD3-34D56D89C490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0821AE4-D7C5-4AE9-934D-1B4CBD3100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C2B6275-3C91-48DD-947C-31931EE0F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8ED735-DF71-46AC-B479-3F093A1108A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42072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8B3EA8-0DD5-459D-80A8-050F84C0E9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3404681-E18B-44CF-AC8A-47790C84E58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F5443B-F1FB-4205-940B-1F8486F2B0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107586D-9166-433B-8C17-4BBA9DE36B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9A55AFB-3C64-4856-B831-447B75ADDE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6851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B1CFA3B-512D-4317-A918-7AB01E2D1DA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A3FC7C6-DC8D-40CD-9266-656FD5B07DB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FA6046-61F6-483F-AC5F-6ABC1C0616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02885B6-FAE5-4592-B1C3-6AB927BE01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2071B14-767D-4971-BFD8-55BD02F3DC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87813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86B8B1-667A-41A9-91A8-5DE4AA9E919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3513B1-2132-4A49-BC77-A65ABDC6070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9FADB13-D0AF-4463-92F4-B7AE3EBCA3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DD1656C-144E-4B7E-9E31-12DAAA5496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1CA3CB0-7690-4C32-8B7A-3DC6402FBD0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21139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D305F1-0672-47AC-8BFA-498890934F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3CB7D88-4FB4-4374-B341-1DC3401FCDC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8C2F843-B10B-4F90-B7C5-1DB18E7980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09A1A49-12C5-4E30-9FB1-6EEB8A957C9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71F1E9-3DAA-4375-A975-62D2AB246E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47424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4B0910-0B57-4391-A3D5-3AAFB4F3AAE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FA0DFF0-F6F1-4200-A7AF-14A511FD3E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8068DA2-089C-4794-B3B7-89B69DCC134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3174D7-538A-4C1F-A867-BBAABF5E9C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D903681-866D-4C6D-AD43-3444B367E0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5232093-AA6B-4EDF-BA5C-F3ED27957EF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088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C543DB-E0EC-44B6-B3D2-55E3883115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8631CCB-7099-426E-9A44-40D7648965D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7E8C464-8DE5-44CE-816B-E0F34248DFB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6BA83DF-17A3-42AE-8EA4-58923A0CD71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FE96612-3553-4FD4-A47A-7F338AE31AB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DAE17DE-E43C-451D-B999-9D6023B364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FB9744C-4351-4B30-B1E2-AE6B42B668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6A3761B-E1EE-41CE-9514-1C10AD484E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76703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465F5AA-4E98-442C-98CD-9F3718BAB8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D946D0-AE57-4D8D-8CA8-0F9253CF4D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146FA22-B90D-4973-AC72-E16A19E5596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2DB737-145B-4F9C-8A90-F4D393E99F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47219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0C3912D-355B-498D-BFB9-EC92D6DEEF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6288F17-2D53-4F79-9B8D-8D96AF548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1A811D2-60E0-489A-B1B6-C2A328BAD2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67597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0C05F4-40C2-46F2-91A0-B68AE98446F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A9F7CC9-E1F0-495E-97C2-292E578C7DA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C6ADBB8-ABA2-4433-B816-9681EE5DD28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A6E57F6-C0AE-4909-86F1-C53769BB97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E07E274-506B-453E-895A-4A947771AB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7DBAEEB-B312-4D97-9794-C9D28239D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92582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F02CA07-B503-4B1D-9337-0618119A17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CD266EF4-9393-4ACF-8BC5-97162E140DF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E7A583A-0D13-4304-956A-AF8E2AE1BB5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075B82-3816-49AD-98A4-E7FCBCE34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007590C-104E-418D-977C-7661117480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140C195-471F-45CA-B6D3-5BDCDE16CD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95349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757B8A0-3D31-4110-BC40-A0D32FB59A5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C8C5E1A-8AF7-4C9F-ADAD-2B721A86D0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D2358A2-1642-41C5-ACC3-2D536F851EF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E49241C-AC5E-4AE2-B72C-EBEA4CC52E96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7FE6FD4-C9E6-411D-A870-488A589F0FD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C4D6643-DDE9-4B62-A45A-9981B0E5A1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C432C-F862-4B8B-A23F-A835ABFDC1D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783560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CC1168BC-B5F6-40A2-BFBC-17574A3B750F}"/>
              </a:ext>
            </a:extLst>
          </p:cNvPr>
          <p:cNvSpPr/>
          <p:nvPr/>
        </p:nvSpPr>
        <p:spPr>
          <a:xfrm>
            <a:off x="3237097" y="763949"/>
            <a:ext cx="5491655" cy="620914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Total PCA patients with confirmed diagnosis date (2014-April 2019) ; N=5725</a:t>
            </a:r>
          </a:p>
        </p:txBody>
      </p:sp>
      <p:sp>
        <p:nvSpPr>
          <p:cNvPr id="5" name="Down Arrow 15">
            <a:extLst>
              <a:ext uri="{FF2B5EF4-FFF2-40B4-BE49-F238E27FC236}">
                <a16:creationId xmlns:a16="http://schemas.microsoft.com/office/drawing/2014/main" id="{6961E47E-980C-4F50-B8CF-DB6CEAD5D25B}"/>
              </a:ext>
            </a:extLst>
          </p:cNvPr>
          <p:cNvSpPr/>
          <p:nvPr/>
        </p:nvSpPr>
        <p:spPr>
          <a:xfrm>
            <a:off x="5891741" y="1420748"/>
            <a:ext cx="231676" cy="569033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801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DAC68E14-80EF-4C56-A39D-BA1E8E42049F}"/>
              </a:ext>
            </a:extLst>
          </p:cNvPr>
          <p:cNvSpPr/>
          <p:nvPr/>
        </p:nvSpPr>
        <p:spPr>
          <a:xfrm>
            <a:off x="3232910" y="2025663"/>
            <a:ext cx="5702368" cy="620914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0" dirty="0"/>
              <a:t>Metastatic Patients (within 3 month of diagnosis); N=</a:t>
            </a:r>
            <a:r>
              <a:rPr lang="en-US" sz="1200" dirty="0">
                <a:ea typeface="+mn-lt"/>
                <a:cs typeface="+mn-lt"/>
              </a:rPr>
              <a:t>240</a:t>
            </a:r>
            <a:endParaRPr lang="en-US" dirty="0"/>
          </a:p>
          <a:p>
            <a:pPr algn="ctr"/>
            <a:endParaRPr lang="en-US" sz="1200" dirty="0"/>
          </a:p>
        </p:txBody>
      </p:sp>
      <p:sp>
        <p:nvSpPr>
          <p:cNvPr id="7" name="Down Arrow 15">
            <a:extLst>
              <a:ext uri="{FF2B5EF4-FFF2-40B4-BE49-F238E27FC236}">
                <a16:creationId xmlns:a16="http://schemas.microsoft.com/office/drawing/2014/main" id="{B2311BB7-073C-45D6-B5BA-A4472DDC8405}"/>
              </a:ext>
            </a:extLst>
          </p:cNvPr>
          <p:cNvSpPr/>
          <p:nvPr/>
        </p:nvSpPr>
        <p:spPr>
          <a:xfrm rot="2400448">
            <a:off x="3870050" y="2637667"/>
            <a:ext cx="156555" cy="6792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801"/>
          </a:p>
        </p:txBody>
      </p:sp>
      <p:sp>
        <p:nvSpPr>
          <p:cNvPr id="8" name="Down Arrow 15">
            <a:extLst>
              <a:ext uri="{FF2B5EF4-FFF2-40B4-BE49-F238E27FC236}">
                <a16:creationId xmlns:a16="http://schemas.microsoft.com/office/drawing/2014/main" id="{330E6A7C-FEF6-4E51-864D-C97BD0055B72}"/>
              </a:ext>
            </a:extLst>
          </p:cNvPr>
          <p:cNvSpPr/>
          <p:nvPr/>
        </p:nvSpPr>
        <p:spPr>
          <a:xfrm rot="18941298">
            <a:off x="8180364" y="2650067"/>
            <a:ext cx="156555" cy="679234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801"/>
          </a:p>
        </p:txBody>
      </p:sp>
      <p:sp>
        <p:nvSpPr>
          <p:cNvPr id="9" name="Rectangle 8">
            <a:extLst>
              <a:ext uri="{FF2B5EF4-FFF2-40B4-BE49-F238E27FC236}">
                <a16:creationId xmlns:a16="http://schemas.microsoft.com/office/drawing/2014/main" id="{4CC84AF6-948A-47B0-8B02-EEE301331A10}"/>
              </a:ext>
            </a:extLst>
          </p:cNvPr>
          <p:cNvSpPr/>
          <p:nvPr/>
        </p:nvSpPr>
        <p:spPr>
          <a:xfrm>
            <a:off x="1650270" y="3293608"/>
            <a:ext cx="4039532" cy="620914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200" dirty="0">
              <a:cs typeface="Calibri"/>
            </a:endParaRPr>
          </a:p>
          <a:p>
            <a:pPr algn="ctr"/>
            <a:r>
              <a:rPr lang="en-US" sz="1200" dirty="0">
                <a:cs typeface="Calibri"/>
              </a:rPr>
              <a:t>Patient treated with docetaxel between 2014- April 2019; N= </a:t>
            </a:r>
            <a:r>
              <a:rPr lang="en-US" sz="1200" dirty="0">
                <a:ea typeface="+mn-lt"/>
                <a:cs typeface="+mn-lt"/>
              </a:rPr>
              <a:t>67</a:t>
            </a:r>
          </a:p>
          <a:p>
            <a:pPr algn="ctr"/>
            <a:endParaRPr lang="en-US" sz="1200" dirty="0">
              <a:cs typeface="Calibri"/>
            </a:endParaRPr>
          </a:p>
          <a:p>
            <a:pPr algn="ctr"/>
            <a:endParaRPr lang="en-US" sz="1200" dirty="0">
              <a:cs typeface="Calibri"/>
            </a:endParaRPr>
          </a:p>
        </p:txBody>
      </p:sp>
      <p:sp>
        <p:nvSpPr>
          <p:cNvPr id="10" name="Rectangle 9">
            <a:extLst>
              <a:ext uri="{FF2B5EF4-FFF2-40B4-BE49-F238E27FC236}">
                <a16:creationId xmlns:a16="http://schemas.microsoft.com/office/drawing/2014/main" id="{AB1D7E88-FAF6-4FB8-BD5B-8DD606313FA6}"/>
              </a:ext>
            </a:extLst>
          </p:cNvPr>
          <p:cNvSpPr/>
          <p:nvPr/>
        </p:nvSpPr>
        <p:spPr>
          <a:xfrm>
            <a:off x="6567182" y="3291939"/>
            <a:ext cx="4039532" cy="620914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200" dirty="0">
              <a:cs typeface="Calibri"/>
            </a:endParaRPr>
          </a:p>
          <a:p>
            <a:pPr algn="ctr"/>
            <a:endParaRPr lang="en-US" sz="1200" dirty="0">
              <a:cs typeface="Calibri"/>
            </a:endParaRPr>
          </a:p>
          <a:p>
            <a:pPr algn="ctr"/>
            <a:r>
              <a:rPr lang="en-US" sz="1200" dirty="0">
                <a:cs typeface="Calibri"/>
              </a:rPr>
              <a:t>Patient treated with NHA between 2017- April 2019; </a:t>
            </a:r>
            <a:endParaRPr lang="en-US" dirty="0"/>
          </a:p>
          <a:p>
            <a:r>
              <a:rPr lang="en-US" sz="1200" b="1" dirty="0">
                <a:ea typeface="+mn-lt"/>
                <a:cs typeface="+mn-lt"/>
              </a:rPr>
              <a:t>                      </a:t>
            </a:r>
            <a:r>
              <a:rPr lang="en-US" sz="1200" dirty="0">
                <a:ea typeface="+mn-lt"/>
                <a:cs typeface="+mn-lt"/>
              </a:rPr>
              <a:t>                            N=99</a:t>
            </a:r>
          </a:p>
          <a:p>
            <a:pPr algn="ctr"/>
            <a:endParaRPr lang="en-US" sz="1200" b="1" dirty="0">
              <a:cs typeface="Calibri"/>
            </a:endParaRPr>
          </a:p>
          <a:p>
            <a:pPr algn="ctr"/>
            <a:endParaRPr lang="en-US" sz="1200" dirty="0"/>
          </a:p>
          <a:p>
            <a:pPr algn="ctr"/>
            <a:endParaRPr lang="en-US" sz="1200" dirty="0">
              <a:cs typeface="Calibri"/>
            </a:endParaRPr>
          </a:p>
        </p:txBody>
      </p:sp>
      <p:sp>
        <p:nvSpPr>
          <p:cNvPr id="11" name="Down Arrow 15">
            <a:extLst>
              <a:ext uri="{FF2B5EF4-FFF2-40B4-BE49-F238E27FC236}">
                <a16:creationId xmlns:a16="http://schemas.microsoft.com/office/drawing/2014/main" id="{458DDDF8-BFAE-4DC2-BB48-81D1FC4AA73C}"/>
              </a:ext>
            </a:extLst>
          </p:cNvPr>
          <p:cNvSpPr/>
          <p:nvPr/>
        </p:nvSpPr>
        <p:spPr>
          <a:xfrm>
            <a:off x="3501190" y="3967431"/>
            <a:ext cx="223934" cy="4601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801"/>
          </a:p>
        </p:txBody>
      </p:sp>
      <p:sp>
        <p:nvSpPr>
          <p:cNvPr id="12" name="Down Arrow 15">
            <a:extLst>
              <a:ext uri="{FF2B5EF4-FFF2-40B4-BE49-F238E27FC236}">
                <a16:creationId xmlns:a16="http://schemas.microsoft.com/office/drawing/2014/main" id="{EFCA3633-BC37-46D0-9A71-3593C3BC3B0E}"/>
              </a:ext>
            </a:extLst>
          </p:cNvPr>
          <p:cNvSpPr/>
          <p:nvPr/>
        </p:nvSpPr>
        <p:spPr>
          <a:xfrm>
            <a:off x="8382013" y="3963421"/>
            <a:ext cx="223934" cy="460190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801"/>
          </a:p>
        </p:txBody>
      </p:sp>
      <p:sp>
        <p:nvSpPr>
          <p:cNvPr id="13" name="Rectangle 12">
            <a:extLst>
              <a:ext uri="{FF2B5EF4-FFF2-40B4-BE49-F238E27FC236}">
                <a16:creationId xmlns:a16="http://schemas.microsoft.com/office/drawing/2014/main" id="{4E2685BE-2BC7-4AD7-B28F-8BA904ECC321}"/>
              </a:ext>
            </a:extLst>
          </p:cNvPr>
          <p:cNvSpPr/>
          <p:nvPr/>
        </p:nvSpPr>
        <p:spPr>
          <a:xfrm>
            <a:off x="1593391" y="4474175"/>
            <a:ext cx="4039532" cy="667792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200" dirty="0">
              <a:cs typeface="Calibri"/>
            </a:endParaRPr>
          </a:p>
          <a:p>
            <a:pPr algn="ctr"/>
            <a:r>
              <a:rPr lang="en-US" sz="1200" dirty="0">
                <a:cs typeface="Calibri"/>
              </a:rPr>
              <a:t>Patient treated with docetaxel between 2014- April 2019, as 1st line (within 6-7 month of diagnosis); N= </a:t>
            </a:r>
            <a:r>
              <a:rPr lang="en-US" sz="1200" dirty="0"/>
              <a:t>52</a:t>
            </a:r>
            <a:endParaRPr lang="en-US" sz="1200" dirty="0">
              <a:cs typeface="Calibri"/>
            </a:endParaRPr>
          </a:p>
          <a:p>
            <a:pPr algn="ctr"/>
            <a:endParaRPr lang="en-US" sz="1200" dirty="0">
              <a:cs typeface="Calibri"/>
            </a:endParaRP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77492B67-6205-4D4F-A026-EC92AF59A4E3}"/>
              </a:ext>
            </a:extLst>
          </p:cNvPr>
          <p:cNvSpPr/>
          <p:nvPr/>
        </p:nvSpPr>
        <p:spPr>
          <a:xfrm>
            <a:off x="6437745" y="4474175"/>
            <a:ext cx="4039532" cy="667792"/>
          </a:xfrm>
          <a:prstGeom prst="rect">
            <a:avLst/>
          </a:prstGeom>
          <a:noFill/>
          <a:ln>
            <a:solidFill>
              <a:schemeClr val="tx2">
                <a:lumMod val="60000"/>
                <a:lumOff val="40000"/>
              </a:schemeClr>
            </a:solidFill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rtlCol="0" anchor="ctr"/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dk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en-US" sz="1200" dirty="0">
              <a:cs typeface="Calibri"/>
            </a:endParaRPr>
          </a:p>
          <a:p>
            <a:pPr algn="ctr"/>
            <a:r>
              <a:rPr lang="en-US" sz="1200" dirty="0">
                <a:cs typeface="Calibri"/>
              </a:rPr>
              <a:t>Patient treated with NHA between 2017- April 2019, as 1st line (within 6-7 month of diagnosis); N=</a:t>
            </a:r>
            <a:r>
              <a:rPr lang="en-US" sz="1200" dirty="0"/>
              <a:t>42</a:t>
            </a:r>
            <a:endParaRPr lang="en-US" sz="1200" dirty="0">
              <a:cs typeface="Calibri"/>
            </a:endParaRPr>
          </a:p>
        </p:txBody>
      </p:sp>
    </p:spTree>
    <p:extLst>
      <p:ext uri="{BB962C8B-B14F-4D97-AF65-F5344CB8AC3E}">
        <p14:creationId xmlns:p14="http://schemas.microsoft.com/office/powerpoint/2010/main" val="39968601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5</Words>
  <Application>Microsoft Office PowerPoint</Application>
  <PresentationFormat>Widescreen</PresentationFormat>
  <Paragraphs>1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nny Guin</dc:creator>
  <cp:lastModifiedBy>Sunny Guin</cp:lastModifiedBy>
  <cp:revision>1</cp:revision>
  <dcterms:created xsi:type="dcterms:W3CDTF">2022-07-05T14:21:47Z</dcterms:created>
  <dcterms:modified xsi:type="dcterms:W3CDTF">2022-07-05T14:23:43Z</dcterms:modified>
</cp:coreProperties>
</file>